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6511588" cy="216185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A4C6"/>
    <a:srgbClr val="FAACEF"/>
    <a:srgbClr val="FF9933"/>
    <a:srgbClr val="FA48E1"/>
    <a:srgbClr val="FB47BB"/>
    <a:srgbClr val="FA32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41" d="100"/>
          <a:sy n="41" d="100"/>
        </p:scale>
        <p:origin x="235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38369" y="3538041"/>
            <a:ext cx="14034850" cy="7526467"/>
          </a:xfrm>
        </p:spPr>
        <p:txBody>
          <a:bodyPr anchor="b"/>
          <a:lstStyle>
            <a:lvl1pPr algn="ctr">
              <a:defRPr sz="1083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63949" y="11354758"/>
            <a:ext cx="12383691" cy="5219483"/>
          </a:xfrm>
        </p:spPr>
        <p:txBody>
          <a:bodyPr/>
          <a:lstStyle>
            <a:lvl1pPr marL="0" indent="0" algn="ctr">
              <a:buNone/>
              <a:defRPr sz="4334"/>
            </a:lvl1pPr>
            <a:lvl2pPr marL="825566" indent="0" algn="ctr">
              <a:buNone/>
              <a:defRPr sz="3611"/>
            </a:lvl2pPr>
            <a:lvl3pPr marL="1651132" indent="0" algn="ctr">
              <a:buNone/>
              <a:defRPr sz="3250"/>
            </a:lvl3pPr>
            <a:lvl4pPr marL="2476698" indent="0" algn="ctr">
              <a:buNone/>
              <a:defRPr sz="2889"/>
            </a:lvl4pPr>
            <a:lvl5pPr marL="3302264" indent="0" algn="ctr">
              <a:buNone/>
              <a:defRPr sz="2889"/>
            </a:lvl5pPr>
            <a:lvl6pPr marL="4127830" indent="0" algn="ctr">
              <a:buNone/>
              <a:defRPr sz="2889"/>
            </a:lvl6pPr>
            <a:lvl7pPr marL="4953396" indent="0" algn="ctr">
              <a:buNone/>
              <a:defRPr sz="2889"/>
            </a:lvl7pPr>
            <a:lvl8pPr marL="5778962" indent="0" algn="ctr">
              <a:buNone/>
              <a:defRPr sz="2889"/>
            </a:lvl8pPr>
            <a:lvl9pPr marL="6604528" indent="0" algn="ctr">
              <a:buNone/>
              <a:defRPr sz="2889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0979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923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816106" y="1150989"/>
            <a:ext cx="3560311" cy="18320743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5172" y="1150989"/>
            <a:ext cx="10474539" cy="1832074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3148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3479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6573" y="5389637"/>
            <a:ext cx="14241245" cy="8992725"/>
          </a:xfrm>
        </p:spPr>
        <p:txBody>
          <a:bodyPr anchor="b"/>
          <a:lstStyle>
            <a:lvl1pPr>
              <a:defRPr sz="10834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6573" y="14467437"/>
            <a:ext cx="14241245" cy="4729062"/>
          </a:xfrm>
        </p:spPr>
        <p:txBody>
          <a:bodyPr/>
          <a:lstStyle>
            <a:lvl1pPr marL="0" indent="0">
              <a:buNone/>
              <a:defRPr sz="4334">
                <a:solidFill>
                  <a:schemeClr val="tx1"/>
                </a:solidFill>
              </a:defRPr>
            </a:lvl1pPr>
            <a:lvl2pPr marL="825566" indent="0">
              <a:buNone/>
              <a:defRPr sz="3611">
                <a:solidFill>
                  <a:schemeClr val="tx1">
                    <a:tint val="75000"/>
                  </a:schemeClr>
                </a:solidFill>
              </a:defRPr>
            </a:lvl2pPr>
            <a:lvl3pPr marL="1651132" indent="0">
              <a:buNone/>
              <a:defRPr sz="3250">
                <a:solidFill>
                  <a:schemeClr val="tx1">
                    <a:tint val="75000"/>
                  </a:schemeClr>
                </a:solidFill>
              </a:defRPr>
            </a:lvl3pPr>
            <a:lvl4pPr marL="2476698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4pPr>
            <a:lvl5pPr marL="3302264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5pPr>
            <a:lvl6pPr marL="412783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6pPr>
            <a:lvl7pPr marL="4953396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7pPr>
            <a:lvl8pPr marL="5778962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8pPr>
            <a:lvl9pPr marL="6604528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7045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5172" y="5754945"/>
            <a:ext cx="7017425" cy="1371678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58991" y="5754945"/>
            <a:ext cx="7017425" cy="1371678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106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7322" y="1150994"/>
            <a:ext cx="14241245" cy="417859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7324" y="5299555"/>
            <a:ext cx="6985175" cy="2597230"/>
          </a:xfrm>
        </p:spPr>
        <p:txBody>
          <a:bodyPr anchor="b"/>
          <a:lstStyle>
            <a:lvl1pPr marL="0" indent="0">
              <a:buNone/>
              <a:defRPr sz="4334" b="1"/>
            </a:lvl1pPr>
            <a:lvl2pPr marL="825566" indent="0">
              <a:buNone/>
              <a:defRPr sz="3611" b="1"/>
            </a:lvl2pPr>
            <a:lvl3pPr marL="1651132" indent="0">
              <a:buNone/>
              <a:defRPr sz="3250" b="1"/>
            </a:lvl3pPr>
            <a:lvl4pPr marL="2476698" indent="0">
              <a:buNone/>
              <a:defRPr sz="2889" b="1"/>
            </a:lvl4pPr>
            <a:lvl5pPr marL="3302264" indent="0">
              <a:buNone/>
              <a:defRPr sz="2889" b="1"/>
            </a:lvl5pPr>
            <a:lvl6pPr marL="4127830" indent="0">
              <a:buNone/>
              <a:defRPr sz="2889" b="1"/>
            </a:lvl6pPr>
            <a:lvl7pPr marL="4953396" indent="0">
              <a:buNone/>
              <a:defRPr sz="2889" b="1"/>
            </a:lvl7pPr>
            <a:lvl8pPr marL="5778962" indent="0">
              <a:buNone/>
              <a:defRPr sz="2889" b="1"/>
            </a:lvl8pPr>
            <a:lvl9pPr marL="6604528" indent="0">
              <a:buNone/>
              <a:defRPr sz="2889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37324" y="7896785"/>
            <a:ext cx="6985175" cy="1161498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58992" y="5299555"/>
            <a:ext cx="7019576" cy="2597230"/>
          </a:xfrm>
        </p:spPr>
        <p:txBody>
          <a:bodyPr anchor="b"/>
          <a:lstStyle>
            <a:lvl1pPr marL="0" indent="0">
              <a:buNone/>
              <a:defRPr sz="4334" b="1"/>
            </a:lvl1pPr>
            <a:lvl2pPr marL="825566" indent="0">
              <a:buNone/>
              <a:defRPr sz="3611" b="1"/>
            </a:lvl2pPr>
            <a:lvl3pPr marL="1651132" indent="0">
              <a:buNone/>
              <a:defRPr sz="3250" b="1"/>
            </a:lvl3pPr>
            <a:lvl4pPr marL="2476698" indent="0">
              <a:buNone/>
              <a:defRPr sz="2889" b="1"/>
            </a:lvl4pPr>
            <a:lvl5pPr marL="3302264" indent="0">
              <a:buNone/>
              <a:defRPr sz="2889" b="1"/>
            </a:lvl5pPr>
            <a:lvl6pPr marL="4127830" indent="0">
              <a:buNone/>
              <a:defRPr sz="2889" b="1"/>
            </a:lvl6pPr>
            <a:lvl7pPr marL="4953396" indent="0">
              <a:buNone/>
              <a:defRPr sz="2889" b="1"/>
            </a:lvl7pPr>
            <a:lvl8pPr marL="5778962" indent="0">
              <a:buNone/>
              <a:defRPr sz="2889" b="1"/>
            </a:lvl8pPr>
            <a:lvl9pPr marL="6604528" indent="0">
              <a:buNone/>
              <a:defRPr sz="2889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58992" y="7896785"/>
            <a:ext cx="7019576" cy="11614981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966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1935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2469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7322" y="1441238"/>
            <a:ext cx="5325417" cy="5044334"/>
          </a:xfrm>
        </p:spPr>
        <p:txBody>
          <a:bodyPr anchor="b"/>
          <a:lstStyle>
            <a:lvl1pPr>
              <a:defRPr sz="5778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019576" y="3112679"/>
            <a:ext cx="8358991" cy="15363200"/>
          </a:xfrm>
        </p:spPr>
        <p:txBody>
          <a:bodyPr/>
          <a:lstStyle>
            <a:lvl1pPr>
              <a:defRPr sz="5778"/>
            </a:lvl1pPr>
            <a:lvl2pPr>
              <a:defRPr sz="5056"/>
            </a:lvl2pPr>
            <a:lvl3pPr>
              <a:defRPr sz="4334"/>
            </a:lvl3pPr>
            <a:lvl4pPr>
              <a:defRPr sz="3611"/>
            </a:lvl4pPr>
            <a:lvl5pPr>
              <a:defRPr sz="3611"/>
            </a:lvl5pPr>
            <a:lvl6pPr>
              <a:defRPr sz="3611"/>
            </a:lvl6pPr>
            <a:lvl7pPr>
              <a:defRPr sz="3611"/>
            </a:lvl7pPr>
            <a:lvl8pPr>
              <a:defRPr sz="3611"/>
            </a:lvl8pPr>
            <a:lvl9pPr>
              <a:defRPr sz="361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7322" y="6485573"/>
            <a:ext cx="5325417" cy="12015325"/>
          </a:xfrm>
        </p:spPr>
        <p:txBody>
          <a:bodyPr/>
          <a:lstStyle>
            <a:lvl1pPr marL="0" indent="0">
              <a:buNone/>
              <a:defRPr sz="2889"/>
            </a:lvl1pPr>
            <a:lvl2pPr marL="825566" indent="0">
              <a:buNone/>
              <a:defRPr sz="2528"/>
            </a:lvl2pPr>
            <a:lvl3pPr marL="1651132" indent="0">
              <a:buNone/>
              <a:defRPr sz="2167"/>
            </a:lvl3pPr>
            <a:lvl4pPr marL="2476698" indent="0">
              <a:buNone/>
              <a:defRPr sz="1806"/>
            </a:lvl4pPr>
            <a:lvl5pPr marL="3302264" indent="0">
              <a:buNone/>
              <a:defRPr sz="1806"/>
            </a:lvl5pPr>
            <a:lvl6pPr marL="4127830" indent="0">
              <a:buNone/>
              <a:defRPr sz="1806"/>
            </a:lvl6pPr>
            <a:lvl7pPr marL="4953396" indent="0">
              <a:buNone/>
              <a:defRPr sz="1806"/>
            </a:lvl7pPr>
            <a:lvl8pPr marL="5778962" indent="0">
              <a:buNone/>
              <a:defRPr sz="1806"/>
            </a:lvl8pPr>
            <a:lvl9pPr marL="6604528" indent="0">
              <a:buNone/>
              <a:defRPr sz="1806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630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7322" y="1441238"/>
            <a:ext cx="5325417" cy="5044334"/>
          </a:xfrm>
        </p:spPr>
        <p:txBody>
          <a:bodyPr anchor="b"/>
          <a:lstStyle>
            <a:lvl1pPr>
              <a:defRPr sz="5778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019576" y="3112679"/>
            <a:ext cx="8358991" cy="15363200"/>
          </a:xfrm>
        </p:spPr>
        <p:txBody>
          <a:bodyPr anchor="t"/>
          <a:lstStyle>
            <a:lvl1pPr marL="0" indent="0">
              <a:buNone/>
              <a:defRPr sz="5778"/>
            </a:lvl1pPr>
            <a:lvl2pPr marL="825566" indent="0">
              <a:buNone/>
              <a:defRPr sz="5056"/>
            </a:lvl2pPr>
            <a:lvl3pPr marL="1651132" indent="0">
              <a:buNone/>
              <a:defRPr sz="4334"/>
            </a:lvl3pPr>
            <a:lvl4pPr marL="2476698" indent="0">
              <a:buNone/>
              <a:defRPr sz="3611"/>
            </a:lvl4pPr>
            <a:lvl5pPr marL="3302264" indent="0">
              <a:buNone/>
              <a:defRPr sz="3611"/>
            </a:lvl5pPr>
            <a:lvl6pPr marL="4127830" indent="0">
              <a:buNone/>
              <a:defRPr sz="3611"/>
            </a:lvl6pPr>
            <a:lvl7pPr marL="4953396" indent="0">
              <a:buNone/>
              <a:defRPr sz="3611"/>
            </a:lvl7pPr>
            <a:lvl8pPr marL="5778962" indent="0">
              <a:buNone/>
              <a:defRPr sz="3611"/>
            </a:lvl8pPr>
            <a:lvl9pPr marL="6604528" indent="0">
              <a:buNone/>
              <a:defRPr sz="3611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7322" y="6485573"/>
            <a:ext cx="5325417" cy="12015325"/>
          </a:xfrm>
        </p:spPr>
        <p:txBody>
          <a:bodyPr/>
          <a:lstStyle>
            <a:lvl1pPr marL="0" indent="0">
              <a:buNone/>
              <a:defRPr sz="2889"/>
            </a:lvl1pPr>
            <a:lvl2pPr marL="825566" indent="0">
              <a:buNone/>
              <a:defRPr sz="2528"/>
            </a:lvl2pPr>
            <a:lvl3pPr marL="1651132" indent="0">
              <a:buNone/>
              <a:defRPr sz="2167"/>
            </a:lvl3pPr>
            <a:lvl4pPr marL="2476698" indent="0">
              <a:buNone/>
              <a:defRPr sz="1806"/>
            </a:lvl4pPr>
            <a:lvl5pPr marL="3302264" indent="0">
              <a:buNone/>
              <a:defRPr sz="1806"/>
            </a:lvl5pPr>
            <a:lvl6pPr marL="4127830" indent="0">
              <a:buNone/>
              <a:defRPr sz="1806"/>
            </a:lvl6pPr>
            <a:lvl7pPr marL="4953396" indent="0">
              <a:buNone/>
              <a:defRPr sz="1806"/>
            </a:lvl7pPr>
            <a:lvl8pPr marL="5778962" indent="0">
              <a:buNone/>
              <a:defRPr sz="1806"/>
            </a:lvl8pPr>
            <a:lvl9pPr marL="6604528" indent="0">
              <a:buNone/>
              <a:defRPr sz="1806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8180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5172" y="1150994"/>
            <a:ext cx="14241245" cy="4178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5172" y="5754945"/>
            <a:ext cx="14241245" cy="137167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5172" y="20037221"/>
            <a:ext cx="3715107" cy="11509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2D77F-2538-4F6A-AC9A-2F4150AA54B1}" type="datetimeFigureOut">
              <a:rPr kumimoji="1" lang="ja-JP" altLang="en-US" smtClean="0"/>
              <a:t>2020/1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69464" y="20037221"/>
            <a:ext cx="5572661" cy="11509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61309" y="20037221"/>
            <a:ext cx="3715107" cy="11509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6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6AFDD-2F30-4A3D-96FC-DE00304F5C8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0709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51132" rtl="0" eaLnBrk="1" latinLnBrk="0" hangingPunct="1">
        <a:lnSpc>
          <a:spcPct val="90000"/>
        </a:lnSpc>
        <a:spcBef>
          <a:spcPct val="0"/>
        </a:spcBef>
        <a:buNone/>
        <a:defRPr kumimoji="1" sz="7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2783" indent="-412783" algn="l" defTabSz="1651132" rtl="0" eaLnBrk="1" latinLnBrk="0" hangingPunct="1">
        <a:lnSpc>
          <a:spcPct val="90000"/>
        </a:lnSpc>
        <a:spcBef>
          <a:spcPts val="1806"/>
        </a:spcBef>
        <a:buFont typeface="Arial" panose="020B0604020202020204" pitchFamily="34" charset="0"/>
        <a:buChar char="•"/>
        <a:defRPr kumimoji="1" sz="5056" kern="1200">
          <a:solidFill>
            <a:schemeClr val="tx1"/>
          </a:solidFill>
          <a:latin typeface="+mn-lt"/>
          <a:ea typeface="+mn-ea"/>
          <a:cs typeface="+mn-cs"/>
        </a:defRPr>
      </a:lvl1pPr>
      <a:lvl2pPr marL="1238349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4334" kern="1200">
          <a:solidFill>
            <a:schemeClr val="tx1"/>
          </a:solidFill>
          <a:latin typeface="+mn-lt"/>
          <a:ea typeface="+mn-ea"/>
          <a:cs typeface="+mn-cs"/>
        </a:defRPr>
      </a:lvl2pPr>
      <a:lvl3pPr marL="2063915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3611" kern="1200">
          <a:solidFill>
            <a:schemeClr val="tx1"/>
          </a:solidFill>
          <a:latin typeface="+mn-lt"/>
          <a:ea typeface="+mn-ea"/>
          <a:cs typeface="+mn-cs"/>
        </a:defRPr>
      </a:lvl3pPr>
      <a:lvl4pPr marL="2889481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4pPr>
      <a:lvl5pPr marL="3715047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5pPr>
      <a:lvl6pPr marL="4540613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6pPr>
      <a:lvl7pPr marL="5366179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7pPr>
      <a:lvl8pPr marL="6191745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8pPr>
      <a:lvl9pPr marL="7017311" indent="-412783" algn="l" defTabSz="1651132" rtl="0" eaLnBrk="1" latinLnBrk="0" hangingPunct="1">
        <a:lnSpc>
          <a:spcPct val="90000"/>
        </a:lnSpc>
        <a:spcBef>
          <a:spcPts val="903"/>
        </a:spcBef>
        <a:buFont typeface="Arial" panose="020B0604020202020204" pitchFamily="34" charset="0"/>
        <a:buChar char="•"/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1pPr>
      <a:lvl2pPr marL="825566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2pPr>
      <a:lvl3pPr marL="1651132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3pPr>
      <a:lvl4pPr marL="2476698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4pPr>
      <a:lvl5pPr marL="3302264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5pPr>
      <a:lvl6pPr marL="4127830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6pPr>
      <a:lvl7pPr marL="4953396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7pPr>
      <a:lvl8pPr marL="5778962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8pPr>
      <a:lvl9pPr marL="6604528" algn="l" defTabSz="1651132" rtl="0" eaLnBrk="1" latinLnBrk="0" hangingPunct="1">
        <a:defRPr kumimoji="1" sz="32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423" y="398585"/>
            <a:ext cx="14142707" cy="15926752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540238" y="16865656"/>
            <a:ext cx="15309362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3200" b="1" smtClean="0"/>
              <a:t>S2 </a:t>
            </a:r>
            <a:r>
              <a:rPr lang="en-US" altLang="ja-JP" sz="3200" b="1" smtClean="0"/>
              <a:t>Figure. </a:t>
            </a:r>
            <a:r>
              <a:rPr lang="en-US" altLang="ja-JP" sz="3200" b="1" dirty="0"/>
              <a:t>Schematic representation of Short Tandem Repeats (STR) types of each loci based on the nucleotide sequence of </a:t>
            </a:r>
            <a:r>
              <a:rPr lang="en-US" altLang="ja-JP" sz="3200" b="1" i="1" dirty="0" err="1"/>
              <a:t>Entamoeba</a:t>
            </a:r>
            <a:r>
              <a:rPr lang="en-US" altLang="ja-JP" sz="3200" b="1" i="1" dirty="0"/>
              <a:t> </a:t>
            </a:r>
            <a:r>
              <a:rPr lang="en-US" altLang="ja-JP" sz="3200" b="1" i="1" dirty="0" err="1"/>
              <a:t>histolytica</a:t>
            </a:r>
            <a:r>
              <a:rPr lang="en-US" altLang="ja-JP" sz="3200" b="1" i="1" dirty="0"/>
              <a:t> </a:t>
            </a:r>
            <a:r>
              <a:rPr lang="en-US" altLang="ja-JP" sz="3200" b="1" dirty="0"/>
              <a:t>isolates from the present two cases.</a:t>
            </a:r>
            <a:endParaRPr lang="ja-JP" altLang="en-US" sz="3200" b="1" dirty="0"/>
          </a:p>
        </p:txBody>
      </p:sp>
    </p:spTree>
    <p:extLst>
      <p:ext uri="{BB962C8B-B14F-4D97-AF65-F5344CB8AC3E}">
        <p14:creationId xmlns:p14="http://schemas.microsoft.com/office/powerpoint/2010/main" val="23447533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</TotalTime>
  <Words>31</Words>
  <Application>Microsoft Office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Watanabe Kouji</dc:creator>
  <cp:lastModifiedBy>Watanabe Kouji</cp:lastModifiedBy>
  <cp:revision>19</cp:revision>
  <dcterms:created xsi:type="dcterms:W3CDTF">2019-03-11T06:07:31Z</dcterms:created>
  <dcterms:modified xsi:type="dcterms:W3CDTF">2020-01-06T03:31:55Z</dcterms:modified>
</cp:coreProperties>
</file>